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5.jpeg" ContentType="image/jpeg"/>
  <Override PartName="/ppt/media/image14.jpeg" ContentType="image/jpeg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12.jpeg" ContentType="image/jpeg"/>
  <Override PartName="/ppt/media/image10.jpeg" ContentType="image/jpeg"/>
  <Override PartName="/ppt/media/image8.jpeg" ContentType="image/jpeg"/>
  <Override PartName="/ppt/media/image13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315200" cy="960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170160" cy="48096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520" bIns="475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142880" y="0"/>
            <a:ext cx="3170520" cy="48096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520" bIns="4752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257120" y="718920"/>
            <a:ext cx="4800600" cy="3600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4680" rIns="94680" tIns="47520" bIns="4752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520" bIns="4752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118080"/>
            <a:ext cx="3170160" cy="48132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520" bIns="4752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142880" y="9118080"/>
            <a:ext cx="3170520" cy="48132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520" bIns="4752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3097489-DACF-4C46-8452-F42D2FA5BBF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sldImg"/>
          </p:nvPr>
        </p:nvSpPr>
        <p:spPr>
          <a:xfrm>
            <a:off x="1257480" y="71928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76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520" bIns="4752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46080"/>
                <a:tab algn="l" pos="1892160"/>
                <a:tab algn="l" pos="2838600"/>
                <a:tab algn="l" pos="3784680"/>
                <a:tab algn="l" pos="4730760"/>
                <a:tab algn="l" pos="5676840"/>
                <a:tab algn="l" pos="6622920"/>
                <a:tab algn="l" pos="7569360"/>
                <a:tab algn="l" pos="8515440"/>
                <a:tab algn="l" pos="9461520"/>
                <a:tab algn="l" pos="10407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Slide Number Placeholder 3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4680" rIns="94680" tIns="47520" bIns="4752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0B25C5-BC54-4B45-A724-3467B1C6B3CA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B15D0A-F6D3-4ED1-96D7-68CE5B1ED6D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D5B964-455C-4CC8-AD5F-564EEEB9A5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6CEDE5-E1F5-49D8-B772-7870E0A939D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9D0403-6B17-40E8-8EAB-7245CC206BE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47067D-AF55-479F-9B7C-D12E39481D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29FA06-55CB-47A4-BCBE-81AECADE9C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69EDF2-EF43-41C3-9B51-E8632BD74F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E08EC5-537C-4F50-801B-E39C92B590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929CE0-12C4-4988-994C-48C3FF3921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0C685B-88B2-41A0-9B5E-A08618E654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2D9D74-037A-488E-83FF-631AD3FE58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B5C70A-1E8A-467F-B906-F7958313F7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4681519-490D-4B6F-9081-7C650CEC722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slideLayout" Target="../slideLayouts/slideLayout1.xml"/><Relationship Id="rId17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110331_01SNU500411_129"/>
          <p:cNvPicPr/>
          <p:nvPr/>
        </p:nvPicPr>
        <p:blipFill>
          <a:blip r:embed="rId1"/>
          <a:stretch/>
        </p:blipFill>
        <p:spPr>
          <a:xfrm>
            <a:off x="804960" y="1509840"/>
            <a:ext cx="1423800" cy="100476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4" descr="110331_01SNU500411_141"/>
          <p:cNvPicPr/>
          <p:nvPr/>
        </p:nvPicPr>
        <p:blipFill>
          <a:blip r:embed="rId2"/>
          <a:stretch/>
        </p:blipFill>
        <p:spPr>
          <a:xfrm>
            <a:off x="2279520" y="1509840"/>
            <a:ext cx="1425600" cy="100476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5" descr="110331_01SNU500411_147"/>
          <p:cNvPicPr/>
          <p:nvPr/>
        </p:nvPicPr>
        <p:blipFill>
          <a:blip r:embed="rId3"/>
          <a:stretch/>
        </p:blipFill>
        <p:spPr>
          <a:xfrm>
            <a:off x="3736800" y="1509840"/>
            <a:ext cx="1425600" cy="100476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6" descr="110331_01SNU500411_153"/>
          <p:cNvPicPr/>
          <p:nvPr/>
        </p:nvPicPr>
        <p:blipFill>
          <a:blip r:embed="rId4"/>
          <a:stretch/>
        </p:blipFill>
        <p:spPr>
          <a:xfrm>
            <a:off x="5194440" y="1509840"/>
            <a:ext cx="1425600" cy="100332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7" descr="110331_01SNU500411_157"/>
          <p:cNvPicPr/>
          <p:nvPr/>
        </p:nvPicPr>
        <p:blipFill>
          <a:blip r:embed="rId5"/>
          <a:stretch/>
        </p:blipFill>
        <p:spPr>
          <a:xfrm>
            <a:off x="6651720" y="1509840"/>
            <a:ext cx="1425600" cy="100332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9" descr="110331_01SNU500411_048"/>
          <p:cNvPicPr/>
          <p:nvPr/>
        </p:nvPicPr>
        <p:blipFill>
          <a:blip r:embed="rId6"/>
          <a:stretch/>
        </p:blipFill>
        <p:spPr>
          <a:xfrm>
            <a:off x="798480" y="2590920"/>
            <a:ext cx="1424160" cy="100332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11" descr="110331_01SNU500411_060"/>
          <p:cNvPicPr/>
          <p:nvPr/>
        </p:nvPicPr>
        <p:blipFill>
          <a:blip r:embed="rId7"/>
          <a:stretch/>
        </p:blipFill>
        <p:spPr>
          <a:xfrm>
            <a:off x="2271600" y="2590920"/>
            <a:ext cx="1424160" cy="100332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12" descr="110331_01SNU500411_066"/>
          <p:cNvPicPr/>
          <p:nvPr/>
        </p:nvPicPr>
        <p:blipFill>
          <a:blip r:embed="rId8"/>
          <a:stretch/>
        </p:blipFill>
        <p:spPr>
          <a:xfrm>
            <a:off x="3728880" y="2590920"/>
            <a:ext cx="1424160" cy="100332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13" descr="110331_01SNU500411_072"/>
          <p:cNvPicPr/>
          <p:nvPr/>
        </p:nvPicPr>
        <p:blipFill>
          <a:blip r:embed="rId9"/>
          <a:stretch/>
        </p:blipFill>
        <p:spPr>
          <a:xfrm>
            <a:off x="5187960" y="2590920"/>
            <a:ext cx="1425600" cy="100332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14" descr="110331_01SNU500411_078"/>
          <p:cNvPicPr/>
          <p:nvPr/>
        </p:nvPicPr>
        <p:blipFill>
          <a:blip r:embed="rId10"/>
          <a:stretch/>
        </p:blipFill>
        <p:spPr>
          <a:xfrm>
            <a:off x="6645240" y="2590920"/>
            <a:ext cx="1425600" cy="100332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16" descr="110331_01SNU500411_209"/>
          <p:cNvPicPr/>
          <p:nvPr/>
        </p:nvPicPr>
        <p:blipFill>
          <a:blip r:embed="rId11"/>
          <a:stretch/>
        </p:blipFill>
        <p:spPr>
          <a:xfrm>
            <a:off x="798480" y="3657600"/>
            <a:ext cx="1424160" cy="100332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18" descr="110331_01SNU500411_221"/>
          <p:cNvPicPr/>
          <p:nvPr/>
        </p:nvPicPr>
        <p:blipFill>
          <a:blip r:embed="rId12"/>
          <a:stretch/>
        </p:blipFill>
        <p:spPr>
          <a:xfrm>
            <a:off x="2271600" y="3657600"/>
            <a:ext cx="1424160" cy="100332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19" descr="110331_01SNU500411_227"/>
          <p:cNvPicPr/>
          <p:nvPr/>
        </p:nvPicPr>
        <p:blipFill>
          <a:blip r:embed="rId13"/>
          <a:stretch/>
        </p:blipFill>
        <p:spPr>
          <a:xfrm>
            <a:off x="3728880" y="3657600"/>
            <a:ext cx="1424160" cy="100332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20" descr="110331_01SNU500411_233"/>
          <p:cNvPicPr/>
          <p:nvPr/>
        </p:nvPicPr>
        <p:blipFill>
          <a:blip r:embed="rId14"/>
          <a:stretch/>
        </p:blipFill>
        <p:spPr>
          <a:xfrm>
            <a:off x="5187960" y="3657600"/>
            <a:ext cx="1425600" cy="100332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21" descr="110331_01SNU500411_239"/>
          <p:cNvPicPr/>
          <p:nvPr/>
        </p:nvPicPr>
        <p:blipFill>
          <a:blip r:embed="rId15"/>
          <a:stretch/>
        </p:blipFill>
        <p:spPr>
          <a:xfrm>
            <a:off x="6645240" y="3657600"/>
            <a:ext cx="1425600" cy="1003320"/>
          </a:xfrm>
          <a:prstGeom prst="rect">
            <a:avLst/>
          </a:prstGeom>
          <a:ln w="0">
            <a:noFill/>
          </a:ln>
        </p:spPr>
      </p:pic>
      <p:sp>
        <p:nvSpPr>
          <p:cNvPr id="63" name="Text Box 30"/>
          <p:cNvSpPr/>
          <p:nvPr/>
        </p:nvSpPr>
        <p:spPr>
          <a:xfrm>
            <a:off x="1298160" y="4762440"/>
            <a:ext cx="30708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33"/>
          <p:cNvSpPr/>
          <p:nvPr/>
        </p:nvSpPr>
        <p:spPr>
          <a:xfrm>
            <a:off x="4267080" y="4749840"/>
            <a:ext cx="84312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5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34"/>
          <p:cNvSpPr/>
          <p:nvPr/>
        </p:nvSpPr>
        <p:spPr>
          <a:xfrm>
            <a:off x="5642640" y="4762440"/>
            <a:ext cx="56160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10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35"/>
          <p:cNvSpPr/>
          <p:nvPr/>
        </p:nvSpPr>
        <p:spPr>
          <a:xfrm>
            <a:off x="6773040" y="4762440"/>
            <a:ext cx="2304000" cy="642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buClr>
                <a:srgbClr val="000000"/>
              </a:buClr>
              <a:buFont typeface="Arial"/>
              <a:buAutoNum type="arabicPlain" startAt="20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(mg/kg)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ABT-700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58"/>
          <p:cNvSpPr/>
          <p:nvPr/>
        </p:nvSpPr>
        <p:spPr>
          <a:xfrm>
            <a:off x="8070840" y="1946160"/>
            <a:ext cx="692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Ki6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59"/>
          <p:cNvSpPr/>
          <p:nvPr/>
        </p:nvSpPr>
        <p:spPr>
          <a:xfrm>
            <a:off x="8091360" y="2819520"/>
            <a:ext cx="6717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Total c-Me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60"/>
          <p:cNvSpPr/>
          <p:nvPr/>
        </p:nvSpPr>
        <p:spPr>
          <a:xfrm>
            <a:off x="8001000" y="3833640"/>
            <a:ext cx="106200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Phospho c-Met (Y1234/5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33"/>
          <p:cNvSpPr/>
          <p:nvPr/>
        </p:nvSpPr>
        <p:spPr>
          <a:xfrm>
            <a:off x="2814480" y="4762440"/>
            <a:ext cx="84312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2.5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7"/>
          <p:cNvSpPr/>
          <p:nvPr/>
        </p:nvSpPr>
        <p:spPr>
          <a:xfrm>
            <a:off x="383040" y="286236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2"/>
          <p:cNvSpPr/>
          <p:nvPr/>
        </p:nvSpPr>
        <p:spPr>
          <a:xfrm>
            <a:off x="383040" y="177948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9"/>
          <p:cNvSpPr/>
          <p:nvPr/>
        </p:nvSpPr>
        <p:spPr>
          <a:xfrm>
            <a:off x="378360" y="392760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4"/>
          <p:cNvSpPr/>
          <p:nvPr/>
        </p:nvSpPr>
        <p:spPr>
          <a:xfrm>
            <a:off x="76320" y="152280"/>
            <a:ext cx="838188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S2. IHC images of SNU5 tumor stud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6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15T18:02:05Z</dcterms:created>
  <dc:creator>wangjy</dc:creator>
  <dc:description/>
  <dc:language>en-US</dc:language>
  <cp:lastModifiedBy>Wang, Jieyi</cp:lastModifiedBy>
  <cp:lastPrinted>2014-07-23T18:19:54Z</cp:lastPrinted>
  <dcterms:modified xsi:type="dcterms:W3CDTF">2015-10-30T23:46:02Z</dcterms:modified>
  <cp:revision>148</cp:revision>
  <dc:subject/>
  <dc:title>Slide 1</dc:title>
</cp:coreProperties>
</file>